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78" r:id="rId2"/>
    <p:sldId id="275" r:id="rId3"/>
    <p:sldId id="271" r:id="rId4"/>
  </p:sldIdLst>
  <p:sldSz cx="9144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D03447BB-5D67-496B-8E87-E561075AD55C}" styleName="深色样式 1 - 强调 3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wholeTbl>
    <a:band1H>
      <a:tcStyle>
        <a:tcBdr/>
        <a:fill>
          <a:solidFill>
            <a:schemeClr val="accent3">
              <a:shade val="60000"/>
            </a:schemeClr>
          </a:solidFill>
        </a:fill>
      </a:tcStyle>
    </a:band1H>
    <a:band1V>
      <a:tcStyle>
        <a:tcBdr/>
        <a:fill>
          <a:solidFill>
            <a:schemeClr val="accent3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3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3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3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74C1A8A3-306A-4EB7-A6B1-4F7E0EB9C5D6}" styleName="中度样式 3 - 强调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7DF18680-E054-41AD-8BC1-D1AEF772440D}" styleName="中度样式 2 - 强调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505E3EF-67EA-436B-97B2-0124C06EBD24}" styleName="中度样式 4 - 强调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22838BEF-8BB2-4498-84A7-C5851F593DF1}" styleName="中度样式 4 - 强调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C4B1156A-380E-4F78-BDF5-A606A8083BF9}" styleName="中度样式 4 - 强调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16D9F66E-5EB9-4882-86FB-DCBF35E3C3E4}" styleName="中度样式 4 - 强调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91EBBBCC-DAD2-459C-BE2E-F6DE35CF9A28}" styleName="深色样式 2 - 强调 3/强调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深色样式 2 - 强调 1/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46F890A9-2807-4EBB-B81D-B2AA78EC7F39}" styleName="深色样式 2 - 强调 5/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31" autoAdjust="0"/>
    <p:restoredTop sz="95370" autoAdjust="0"/>
  </p:normalViewPr>
  <p:slideViewPr>
    <p:cSldViewPr snapToGrid="0">
      <p:cViewPr varScale="1">
        <p:scale>
          <a:sx n="86" d="100"/>
          <a:sy n="86" d="100"/>
        </p:scale>
        <p:origin x="24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3B89F8-7756-42E1-83EC-E75863D5C7C1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60550" y="1143000"/>
            <a:ext cx="3136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1A8FD7-7B6A-444F-AB71-D19A5801268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82155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1A8FD7-7B6A-444F-AB71-D19A5801268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58982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860550" y="1143000"/>
            <a:ext cx="31369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Yellow boxes indicate Arabidopsis chromosomes, red boxes indicate maize chromosomes, and green boxes indicate rice chromosomes. Red lines indicate homologous genes of EPF/EPFL family members in different species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1A8FD7-7B6A-444F-AB71-D19A5801268E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3286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860550" y="1143000"/>
            <a:ext cx="31369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The blue boxes indicate the chromosomes of maize, Red lines indicate homologous genes of EPF/EPFL family members in </a:t>
            </a:r>
            <a:r>
              <a:rPr lang="en-US" altLang="zh-CN" i="1" dirty="0" err="1"/>
              <a:t>Zea</a:t>
            </a:r>
            <a:r>
              <a:rPr lang="en-US" altLang="zh-CN" i="1" dirty="0"/>
              <a:t> mays</a:t>
            </a:r>
            <a:r>
              <a:rPr lang="en-US" altLang="zh-CN" dirty="0"/>
              <a:t>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1A8FD7-7B6A-444F-AB71-D19A5801268E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84039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72842"/>
            <a:ext cx="7772400" cy="313317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726842"/>
            <a:ext cx="6858000" cy="217280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9920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9154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79142"/>
            <a:ext cx="1971675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79142"/>
            <a:ext cx="5800725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4213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478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243638"/>
            <a:ext cx="7886700" cy="374355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022610"/>
            <a:ext cx="7886700" cy="196864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551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2453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79144"/>
            <a:ext cx="78867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206137"/>
            <a:ext cx="3868340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287331"/>
            <a:ext cx="3868340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206137"/>
            <a:ext cx="3887391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287331"/>
            <a:ext cx="3887391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0250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6566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0268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295769"/>
            <a:ext cx="4629150" cy="639550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9165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295769"/>
            <a:ext cx="4629150" cy="639550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3854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79144"/>
            <a:ext cx="78867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395710"/>
            <a:ext cx="78867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8341240"/>
            <a:ext cx="20574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801A4-0FBD-4B6E-A4BE-5D907E147A9C}" type="datetimeFigureOut">
              <a:rPr lang="zh-CN" altLang="en-US" smtClean="0"/>
              <a:t>2024/4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8341240"/>
            <a:ext cx="30861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8341240"/>
            <a:ext cx="20574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4DD65C-24E5-4EC5-BEF4-7B42C9E8FBC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343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E9E3D22-7A35-D5EF-6C7A-28727ADCDF06}"/>
              </a:ext>
            </a:extLst>
          </p:cNvPr>
          <p:cNvSpPr txBox="1"/>
          <p:nvPr/>
        </p:nvSpPr>
        <p:spPr>
          <a:xfrm>
            <a:off x="730641" y="7543835"/>
            <a:ext cx="76827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Domain prediction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ZmEPF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ZmEPFL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family members.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green box represents the EPF domain, the yellow box represents the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tomage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like superfamily domain, and the red box represents the PLN03207 domain. Protein length refers to the scale below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CC2ED371-CF13-8471-9090-BFD978C34CD4}"/>
              </a:ext>
            </a:extLst>
          </p:cNvPr>
          <p:cNvGrpSpPr/>
          <p:nvPr/>
        </p:nvGrpSpPr>
        <p:grpSpPr>
          <a:xfrm>
            <a:off x="1487277" y="622031"/>
            <a:ext cx="5599669" cy="6609723"/>
            <a:chOff x="2060154" y="533896"/>
            <a:chExt cx="5599669" cy="6609723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5F661ADE-8A68-30A2-42CB-3CBB45135E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175" t="3300" r="5531" b="5369"/>
            <a:stretch/>
          </p:blipFill>
          <p:spPr>
            <a:xfrm>
              <a:off x="3249976" y="533896"/>
              <a:ext cx="4409847" cy="6263511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56572B4-9EB2-B61F-AED9-DC127D108270}"/>
                </a:ext>
              </a:extLst>
            </p:cNvPr>
            <p:cNvSpPr txBox="1"/>
            <p:nvPr/>
          </p:nvSpPr>
          <p:spPr>
            <a:xfrm>
              <a:off x="2590207" y="611600"/>
              <a:ext cx="565861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5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35A5BF06-BCE7-D949-640C-8C0798DDE4B9}"/>
                </a:ext>
              </a:extLst>
            </p:cNvPr>
            <p:cNvSpPr txBox="1"/>
            <p:nvPr/>
          </p:nvSpPr>
          <p:spPr>
            <a:xfrm>
              <a:off x="2590207" y="954833"/>
              <a:ext cx="565861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2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568329C4-AA6F-50B8-F2EA-C20347C9EFD2}"/>
                </a:ext>
              </a:extLst>
            </p:cNvPr>
            <p:cNvSpPr txBox="1"/>
            <p:nvPr/>
          </p:nvSpPr>
          <p:spPr>
            <a:xfrm>
              <a:off x="2590207" y="1291927"/>
              <a:ext cx="565861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1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646835CF-11AB-364E-337C-62C77BCC8792}"/>
                </a:ext>
              </a:extLst>
            </p:cNvPr>
            <p:cNvSpPr txBox="1"/>
            <p:nvPr/>
          </p:nvSpPr>
          <p:spPr>
            <a:xfrm>
              <a:off x="2511661" y="1671005"/>
              <a:ext cx="644407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15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6C32EB4-70CD-FFE2-707C-CA136193604B}"/>
                </a:ext>
              </a:extLst>
            </p:cNvPr>
            <p:cNvSpPr txBox="1"/>
            <p:nvPr/>
          </p:nvSpPr>
          <p:spPr>
            <a:xfrm>
              <a:off x="2590207" y="2002379"/>
              <a:ext cx="565861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3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7B1362CE-750F-AA12-8646-7CB3612DA6B7}"/>
                </a:ext>
              </a:extLst>
            </p:cNvPr>
            <p:cNvSpPr txBox="1"/>
            <p:nvPr/>
          </p:nvSpPr>
          <p:spPr>
            <a:xfrm>
              <a:off x="2511661" y="2333115"/>
              <a:ext cx="644407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14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4001B50-DCBE-AAAD-709C-0D368CC0E65B}"/>
                </a:ext>
              </a:extLst>
            </p:cNvPr>
            <p:cNvSpPr txBox="1"/>
            <p:nvPr/>
          </p:nvSpPr>
          <p:spPr>
            <a:xfrm>
              <a:off x="2590207" y="2680562"/>
              <a:ext cx="565861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4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FBDDB86-1583-CC52-F850-B47452F59355}"/>
                </a:ext>
              </a:extLst>
            </p:cNvPr>
            <p:cNvSpPr txBox="1"/>
            <p:nvPr/>
          </p:nvSpPr>
          <p:spPr>
            <a:xfrm>
              <a:off x="2590207" y="3034358"/>
              <a:ext cx="565861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7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9AAE9F2-8CD8-34A5-AC44-A1B7778F4FBD}"/>
                </a:ext>
              </a:extLst>
            </p:cNvPr>
            <p:cNvSpPr txBox="1"/>
            <p:nvPr/>
          </p:nvSpPr>
          <p:spPr>
            <a:xfrm>
              <a:off x="2511661" y="3396734"/>
              <a:ext cx="644407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13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18C18D9-AD0D-CA41-E32E-83AE73F72326}"/>
                </a:ext>
              </a:extLst>
            </p:cNvPr>
            <p:cNvSpPr txBox="1"/>
            <p:nvPr/>
          </p:nvSpPr>
          <p:spPr>
            <a:xfrm>
              <a:off x="2590207" y="3735601"/>
              <a:ext cx="565861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9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C6E881D-0078-FD76-E11F-E00C102771BF}"/>
                </a:ext>
              </a:extLst>
            </p:cNvPr>
            <p:cNvSpPr txBox="1"/>
            <p:nvPr/>
          </p:nvSpPr>
          <p:spPr>
            <a:xfrm>
              <a:off x="2511661" y="4085834"/>
              <a:ext cx="644407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12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5E241C79-6557-8F4C-F2E6-C833D32FFBA5}"/>
                </a:ext>
              </a:extLst>
            </p:cNvPr>
            <p:cNvSpPr txBox="1"/>
            <p:nvPr/>
          </p:nvSpPr>
          <p:spPr>
            <a:xfrm>
              <a:off x="2503645" y="4436067"/>
              <a:ext cx="652423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L1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435F2F17-3C2B-B37D-A7B2-F5F4E5049253}"/>
                </a:ext>
              </a:extLst>
            </p:cNvPr>
            <p:cNvSpPr txBox="1"/>
            <p:nvPr/>
          </p:nvSpPr>
          <p:spPr>
            <a:xfrm>
              <a:off x="2590207" y="4786300"/>
              <a:ext cx="565861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6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C861AC1-1916-0C5A-FFEF-F346B74C4F10}"/>
                </a:ext>
              </a:extLst>
            </p:cNvPr>
            <p:cNvSpPr txBox="1"/>
            <p:nvPr/>
          </p:nvSpPr>
          <p:spPr>
            <a:xfrm>
              <a:off x="2511661" y="5123098"/>
              <a:ext cx="644407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10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6663FFF2-2422-9429-DEB0-A4D55C1CA8FD}"/>
                </a:ext>
              </a:extLst>
            </p:cNvPr>
            <p:cNvSpPr txBox="1"/>
            <p:nvPr/>
          </p:nvSpPr>
          <p:spPr>
            <a:xfrm>
              <a:off x="2511661" y="5459896"/>
              <a:ext cx="644407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11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A364A74-CB12-E060-1442-F5B9044DAA75}"/>
                </a:ext>
              </a:extLst>
            </p:cNvPr>
            <p:cNvSpPr txBox="1"/>
            <p:nvPr/>
          </p:nvSpPr>
          <p:spPr>
            <a:xfrm>
              <a:off x="2590207" y="5810129"/>
              <a:ext cx="565861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8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BBD05D0-9686-D122-722C-AA99220C36BB}"/>
                </a:ext>
              </a:extLst>
            </p:cNvPr>
            <p:cNvSpPr txBox="1"/>
            <p:nvPr/>
          </p:nvSpPr>
          <p:spPr>
            <a:xfrm>
              <a:off x="2503645" y="6160362"/>
              <a:ext cx="652423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L2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480D1DE2-867D-5CE1-2498-15E381DEB6A0}"/>
                </a:ext>
              </a:extLst>
            </p:cNvPr>
            <p:cNvSpPr txBox="1"/>
            <p:nvPr/>
          </p:nvSpPr>
          <p:spPr>
            <a:xfrm>
              <a:off x="2503645" y="6498748"/>
              <a:ext cx="652423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ZmEPFL3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5F661ADE-8A68-30A2-42CB-3CBB45135E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" t="94630" r="5531"/>
            <a:stretch/>
          </p:blipFill>
          <p:spPr>
            <a:xfrm>
              <a:off x="2060154" y="6775373"/>
              <a:ext cx="5599669" cy="36824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770970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DE0C309-728A-C6C1-4C9A-AC05B2DC591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357963"/>
            <a:ext cx="9144000" cy="262493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09652C43-259A-FC78-BA01-B0F50B786D73}"/>
              </a:ext>
            </a:extLst>
          </p:cNvPr>
          <p:cNvSpPr txBox="1"/>
          <p:nvPr/>
        </p:nvSpPr>
        <p:spPr>
          <a:xfrm>
            <a:off x="275279" y="6625446"/>
            <a:ext cx="85934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Collinearity of EPFs/EPFLs in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 thaliana, </a:t>
            </a:r>
            <a:r>
              <a:rPr lang="en-US" altLang="zh-CN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Zea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mays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Oryza sativa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Yellow boxes indicate Arabidopsis chromosomes, red boxes indicate maize chromosomes, and green boxes indicate rice chromosomes. Red lines indicate homologous genes of EPF/EPFL family members in different species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91399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1841C2FE-4CA6-E06A-93A5-F11AFD2F65A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7" t="1884" r="15764" b="1884"/>
          <a:stretch/>
        </p:blipFill>
        <p:spPr>
          <a:xfrm>
            <a:off x="1298448" y="456882"/>
            <a:ext cx="6547104" cy="608482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5EC281E-1CFA-AB3B-A95E-5780F07CB220}"/>
              </a:ext>
            </a:extLst>
          </p:cNvPr>
          <p:cNvSpPr txBox="1"/>
          <p:nvPr/>
        </p:nvSpPr>
        <p:spPr>
          <a:xfrm>
            <a:off x="397700" y="7002342"/>
            <a:ext cx="8348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Collinearity of EPFs/EPFLs in </a:t>
            </a:r>
            <a:r>
              <a:rPr lang="en-US" altLang="zh-CN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Zea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may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blue boxes indicate the chromosomes of maize, Red lines indicate homologous genes of EPF/EPFL family members in </a:t>
            </a:r>
            <a:r>
              <a:rPr lang="en-US" altLang="zh-CN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Zea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 mays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453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276</TotalTime>
  <Words>213</Words>
  <Application>Microsoft Office PowerPoint</Application>
  <PresentationFormat>自定义</PresentationFormat>
  <Paragraphs>29</Paragraphs>
  <Slides>3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aoshk5233@163.com</dc:creator>
  <cp:lastModifiedBy>士凯 曹</cp:lastModifiedBy>
  <cp:revision>242</cp:revision>
  <dcterms:created xsi:type="dcterms:W3CDTF">2024-01-08T07:43:48Z</dcterms:created>
  <dcterms:modified xsi:type="dcterms:W3CDTF">2024-04-15T04:13:04Z</dcterms:modified>
</cp:coreProperties>
</file>